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 type="screen4x3"/>
  <p:notesSz cx="6811963" cy="99456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00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21943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32531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70461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24538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40587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9831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77984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13381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36662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66363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65715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6695A9-37E2-4A34-8276-88D9EC34AC2B}" type="datetimeFigureOut">
              <a:rPr lang="en-US" smtClean="0"/>
              <a:pPr/>
              <a:t>9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D325D-757E-424E-B098-653A8DCC912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12514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8153400" cy="1470025"/>
          </a:xfrm>
        </p:spPr>
        <p:txBody>
          <a:bodyPr>
            <a:normAutofit/>
          </a:bodyPr>
          <a:lstStyle/>
          <a:p>
            <a:pPr algn="l"/>
            <a:r>
              <a:rPr lang="en-US" sz="2000" dirty="0" err="1" smtClean="0"/>
              <a:t>Electropherograms</a:t>
            </a:r>
            <a:r>
              <a:rPr lang="en-US" sz="2000" dirty="0" smtClean="0"/>
              <a:t> of the 11 silent mutations in </a:t>
            </a:r>
            <a:r>
              <a:rPr lang="en-US" sz="2000" dirty="0" smtClean="0"/>
              <a:t>EGFR </a:t>
            </a:r>
            <a:r>
              <a:rPr lang="en-US" sz="2000" dirty="0" err="1" smtClean="0"/>
              <a:t>exons</a:t>
            </a:r>
            <a:r>
              <a:rPr lang="en-US" sz="2000" dirty="0" smtClean="0"/>
              <a:t> 19–23 detected in </a:t>
            </a:r>
            <a:r>
              <a:rPr lang="en-US" sz="2000" dirty="0" err="1" smtClean="0"/>
              <a:t>hepatocellular</a:t>
            </a:r>
            <a:r>
              <a:rPr lang="en-US" sz="2000" dirty="0" smtClean="0"/>
              <a:t> carcinoma tissues. </a:t>
            </a:r>
            <a:r>
              <a:rPr lang="en-US" sz="2000" dirty="0" smtClean="0"/>
              <a:t>(</a:t>
            </a:r>
            <a:r>
              <a:rPr lang="en-US" sz="2000" dirty="0" smtClean="0"/>
              <a:t>linked to Table4 in the main text)</a:t>
            </a:r>
            <a:endParaRPr lang="en-US" sz="20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184564" y="1054416"/>
            <a:ext cx="6400800" cy="3746183"/>
            <a:chOff x="1184564" y="1054416"/>
            <a:chExt cx="6400800" cy="3746183"/>
          </a:xfrm>
        </p:grpSpPr>
        <p:grpSp>
          <p:nvGrpSpPr>
            <p:cNvPr id="3" name="Group 2"/>
            <p:cNvGrpSpPr/>
            <p:nvPr/>
          </p:nvGrpSpPr>
          <p:grpSpPr>
            <a:xfrm>
              <a:off x="1184564" y="3089292"/>
              <a:ext cx="6400800" cy="1711307"/>
              <a:chOff x="1489151" y="3248025"/>
              <a:chExt cx="5854624" cy="1276350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6723"/>
              <a:stretch/>
            </p:blipFill>
            <p:spPr bwMode="auto">
              <a:xfrm>
                <a:off x="2057400" y="3248025"/>
                <a:ext cx="5286375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1489151" y="3248025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1184564" y="1054416"/>
              <a:ext cx="6400800" cy="1872583"/>
              <a:chOff x="1524000" y="1327666"/>
              <a:chExt cx="5762624" cy="1599334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5832"/>
              <a:stretch/>
            </p:blipFill>
            <p:spPr bwMode="auto">
              <a:xfrm>
                <a:off x="2057400" y="1650650"/>
                <a:ext cx="5229224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524000" y="1327666"/>
                <a:ext cx="685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7" name="TextBox 6"/>
          <p:cNvSpPr txBox="1"/>
          <p:nvPr/>
        </p:nvSpPr>
        <p:spPr>
          <a:xfrm>
            <a:off x="1524000" y="5410200"/>
            <a:ext cx="3886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447800" y="5594866"/>
            <a:ext cx="571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5T p.Y891Y(c.2673T&gt;C, TAT&gt;TAC)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4672013" y="1596133"/>
            <a:ext cx="357188" cy="320446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5828741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219200" y="5334000"/>
            <a:ext cx="464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</a:t>
            </a:r>
            <a:r>
              <a:rPr lang="en-US" dirty="0"/>
              <a:t>6T   </a:t>
            </a:r>
            <a:r>
              <a:rPr lang="en-US" dirty="0" smtClean="0"/>
              <a:t>p.P919P(c.2757T&gt;C, CCT&gt;CCC)</a:t>
            </a:r>
            <a:endParaRPr lang="en-US" dirty="0"/>
          </a:p>
        </p:txBody>
      </p:sp>
      <p:grpSp>
        <p:nvGrpSpPr>
          <p:cNvPr id="6" name="Group 5"/>
          <p:cNvGrpSpPr/>
          <p:nvPr/>
        </p:nvGrpSpPr>
        <p:grpSpPr>
          <a:xfrm>
            <a:off x="1600200" y="3214687"/>
            <a:ext cx="6400800" cy="1704975"/>
            <a:chOff x="1828800" y="2362200"/>
            <a:chExt cx="5233988" cy="170497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81213" y="2790825"/>
              <a:ext cx="4981575" cy="1276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1828800" y="2362200"/>
              <a:ext cx="685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MT</a:t>
              </a:r>
              <a:endParaRPr lang="en-US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461694" y="1219200"/>
            <a:ext cx="6539306" cy="1887685"/>
            <a:chOff x="1541195" y="1524000"/>
            <a:chExt cx="6248400" cy="167726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0537" y="1924915"/>
              <a:ext cx="5829058" cy="1276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1541195" y="1524000"/>
              <a:ext cx="8386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WT</a:t>
              </a:r>
              <a:endParaRPr lang="en-US" dirty="0"/>
            </a:p>
          </p:txBody>
        </p:sp>
      </p:grpSp>
      <p:sp>
        <p:nvSpPr>
          <p:cNvPr id="9" name="Rectangle 8"/>
          <p:cNvSpPr/>
          <p:nvPr/>
        </p:nvSpPr>
        <p:spPr>
          <a:xfrm>
            <a:off x="5334000" y="1714563"/>
            <a:ext cx="381000" cy="339083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61731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676400" y="1066800"/>
            <a:ext cx="4953000" cy="4154423"/>
            <a:chOff x="1676400" y="1066800"/>
            <a:chExt cx="4953000" cy="4154423"/>
          </a:xfrm>
        </p:grpSpPr>
        <p:grpSp>
          <p:nvGrpSpPr>
            <p:cNvPr id="10" name="Group 9"/>
            <p:cNvGrpSpPr/>
            <p:nvPr/>
          </p:nvGrpSpPr>
          <p:grpSpPr>
            <a:xfrm>
              <a:off x="1676400" y="3409236"/>
              <a:ext cx="4870532" cy="1811987"/>
              <a:chOff x="1299390" y="3124200"/>
              <a:chExt cx="4197927" cy="1791712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-1257" t="3280" r="28157" b="-3280"/>
              <a:stretch/>
            </p:blipFill>
            <p:spPr bwMode="auto">
              <a:xfrm>
                <a:off x="1299390" y="3538707"/>
                <a:ext cx="4197927" cy="13772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1317587" y="3124200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1676400" y="1066800"/>
              <a:ext cx="4953000" cy="1885950"/>
              <a:chOff x="1752600" y="1600200"/>
              <a:chExt cx="4236026" cy="1581150"/>
            </a:xfrm>
          </p:grpSpPr>
          <p:pic>
            <p:nvPicPr>
              <p:cNvPr id="2053" name="Picture 5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34282" r="5367"/>
              <a:stretch/>
            </p:blipFill>
            <p:spPr bwMode="auto">
              <a:xfrm>
                <a:off x="2171699" y="1905000"/>
                <a:ext cx="3816927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1752600" y="1600200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13" name="TextBox 12"/>
          <p:cNvSpPr txBox="1"/>
          <p:nvPr/>
        </p:nvSpPr>
        <p:spPr>
          <a:xfrm>
            <a:off x="838200" y="5791200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45T    E932E(c.2793G&gt;A,GAA&gt;GAG</a:t>
            </a:r>
            <a:r>
              <a:rPr lang="en-US" dirty="0"/>
              <a:t>)</a:t>
            </a:r>
          </a:p>
          <a:p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4038600" y="1507329"/>
            <a:ext cx="457200" cy="366820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028286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295400" y="4876800"/>
            <a:ext cx="472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36T  p.P733P  (c2199A&gt;G, CCA&gt;CCG)</a:t>
            </a:r>
            <a:endParaRPr lang="en-US" dirty="0"/>
          </a:p>
          <a:p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1555682" y="1474287"/>
            <a:ext cx="5828966" cy="5408387"/>
            <a:chOff x="1555682" y="1474287"/>
            <a:chExt cx="5828966" cy="5408387"/>
          </a:xfrm>
        </p:grpSpPr>
        <p:grpSp>
          <p:nvGrpSpPr>
            <p:cNvPr id="9" name="Group 8"/>
            <p:cNvGrpSpPr/>
            <p:nvPr/>
          </p:nvGrpSpPr>
          <p:grpSpPr>
            <a:xfrm>
              <a:off x="1555682" y="1474287"/>
              <a:ext cx="5828966" cy="1542194"/>
              <a:chOff x="1455004" y="636495"/>
              <a:chExt cx="5978360" cy="1542194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3871"/>
              <a:stretch/>
            </p:blipFill>
            <p:spPr bwMode="auto">
              <a:xfrm>
                <a:off x="2015636" y="838200"/>
                <a:ext cx="5417728" cy="13404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1455004" y="636495"/>
                <a:ext cx="609600" cy="381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1555682" y="3194089"/>
              <a:ext cx="5774292" cy="3688585"/>
              <a:chOff x="1605002" y="2624348"/>
              <a:chExt cx="5774292" cy="3688585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1861368" y="2670517"/>
                <a:ext cx="5517926" cy="3642416"/>
                <a:chOff x="893218" y="2514600"/>
                <a:chExt cx="6650582" cy="4008042"/>
              </a:xfrm>
            </p:grpSpPr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93218" y="2514600"/>
                  <a:ext cx="6650582" cy="15525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4" name="TextBox 3"/>
                <p:cNvSpPr txBox="1"/>
                <p:nvPr/>
              </p:nvSpPr>
              <p:spPr>
                <a:xfrm>
                  <a:off x="5245131" y="6116236"/>
                  <a:ext cx="651765" cy="40640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10" name="TextBox 9"/>
              <p:cNvSpPr txBox="1"/>
              <p:nvPr/>
            </p:nvSpPr>
            <p:spPr>
              <a:xfrm>
                <a:off x="1605002" y="2624348"/>
                <a:ext cx="55354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</p:grpSp>
      <p:sp>
        <p:nvSpPr>
          <p:cNvPr id="14" name="Rectangle 13"/>
          <p:cNvSpPr/>
          <p:nvPr/>
        </p:nvSpPr>
        <p:spPr>
          <a:xfrm>
            <a:off x="5029200" y="1474287"/>
            <a:ext cx="402092" cy="31769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88943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33400" y="5334000"/>
            <a:ext cx="5181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41T  p.E734E (c.2202A&gt;G,</a:t>
            </a:r>
            <a:r>
              <a:rPr lang="en-US" dirty="0"/>
              <a:t> </a:t>
            </a:r>
            <a:r>
              <a:rPr lang="en-US" dirty="0" smtClean="0"/>
              <a:t>GAA&gt;GAG</a:t>
            </a:r>
            <a:r>
              <a:rPr lang="en-US" dirty="0"/>
              <a:t>)</a:t>
            </a:r>
          </a:p>
          <a:p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1723580" y="1060180"/>
            <a:ext cx="5763880" cy="3452527"/>
            <a:chOff x="1723580" y="1060180"/>
            <a:chExt cx="5763880" cy="3452527"/>
          </a:xfrm>
        </p:grpSpPr>
        <p:grpSp>
          <p:nvGrpSpPr>
            <p:cNvPr id="5" name="Group 4"/>
            <p:cNvGrpSpPr/>
            <p:nvPr/>
          </p:nvGrpSpPr>
          <p:grpSpPr>
            <a:xfrm>
              <a:off x="1744362" y="2883932"/>
              <a:ext cx="5743098" cy="1628775"/>
              <a:chOff x="1752600" y="2514600"/>
              <a:chExt cx="6294817" cy="1998107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7096" r="1994"/>
              <a:stretch/>
            </p:blipFill>
            <p:spPr bwMode="auto">
              <a:xfrm>
                <a:off x="1925676" y="2883932"/>
                <a:ext cx="6121741" cy="1628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752600" y="2514600"/>
                <a:ext cx="609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1723580" y="1060180"/>
              <a:ext cx="5708462" cy="1639086"/>
              <a:chOff x="1723580" y="1060180"/>
              <a:chExt cx="5708462" cy="1639086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r="6930"/>
              <a:stretch/>
            </p:blipFill>
            <p:spPr bwMode="auto">
              <a:xfrm>
                <a:off x="1744751" y="1244846"/>
                <a:ext cx="5687291" cy="14544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1723580" y="1060180"/>
                <a:ext cx="92932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9" name="Rectangle 8"/>
          <p:cNvSpPr/>
          <p:nvPr/>
        </p:nvSpPr>
        <p:spPr>
          <a:xfrm>
            <a:off x="5181600" y="1429511"/>
            <a:ext cx="381000" cy="306241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073317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38200" y="5562600"/>
            <a:ext cx="60336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10T p.A750A(c.2250A&gt;G,GCA&gt;GCG)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1824214" y="1310563"/>
            <a:ext cx="5871985" cy="3490036"/>
            <a:chOff x="1824214" y="1310563"/>
            <a:chExt cx="5871985" cy="3490036"/>
          </a:xfrm>
        </p:grpSpPr>
        <p:grpSp>
          <p:nvGrpSpPr>
            <p:cNvPr id="6" name="Group 5"/>
            <p:cNvGrpSpPr/>
            <p:nvPr/>
          </p:nvGrpSpPr>
          <p:grpSpPr>
            <a:xfrm>
              <a:off x="1824214" y="3176003"/>
              <a:ext cx="5871985" cy="1624596"/>
              <a:chOff x="1736580" y="2867707"/>
              <a:chExt cx="6035820" cy="1782530"/>
            </a:xfrm>
          </p:grpSpPr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36580" y="3124199"/>
                <a:ext cx="6035820" cy="15260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825336" y="2867707"/>
                <a:ext cx="990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2047784" y="1310563"/>
              <a:ext cx="5620706" cy="1865439"/>
              <a:chOff x="2047784" y="1310563"/>
              <a:chExt cx="5620706" cy="1865439"/>
            </a:xfrm>
          </p:grpSpPr>
          <p:pic>
            <p:nvPicPr>
              <p:cNvPr id="3075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7180" r="12427"/>
              <a:stretch/>
            </p:blipFill>
            <p:spPr bwMode="auto">
              <a:xfrm>
                <a:off x="2142259" y="1679895"/>
                <a:ext cx="5526231" cy="1496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2047784" y="1310563"/>
                <a:ext cx="68926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9" name="Rectangle 8"/>
          <p:cNvSpPr/>
          <p:nvPr/>
        </p:nvSpPr>
        <p:spPr>
          <a:xfrm>
            <a:off x="5486400" y="1679895"/>
            <a:ext cx="457200" cy="319690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31914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75826" y="533400"/>
            <a:ext cx="7429974" cy="5169932"/>
            <a:chOff x="875826" y="533400"/>
            <a:chExt cx="7429974" cy="5169932"/>
          </a:xfrm>
        </p:grpSpPr>
        <p:grpSp>
          <p:nvGrpSpPr>
            <p:cNvPr id="5" name="Group 4"/>
            <p:cNvGrpSpPr/>
            <p:nvPr/>
          </p:nvGrpSpPr>
          <p:grpSpPr>
            <a:xfrm>
              <a:off x="2114615" y="2362201"/>
              <a:ext cx="6191185" cy="2542308"/>
              <a:chOff x="1828800" y="2362200"/>
              <a:chExt cx="4959928" cy="1704976"/>
            </a:xfrm>
          </p:grpSpPr>
          <p:pic>
            <p:nvPicPr>
              <p:cNvPr id="4098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r="6580"/>
              <a:stretch/>
            </p:blipFill>
            <p:spPr bwMode="auto">
              <a:xfrm>
                <a:off x="2019301" y="2790826"/>
                <a:ext cx="4769427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828800" y="2362200"/>
                <a:ext cx="685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875826" y="5334000"/>
              <a:ext cx="5029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ase 56T  p.K754K( c.2262A&gt;G,AAA&gt;AAG)</a:t>
              </a:r>
              <a:endParaRPr lang="en-US" dirty="0"/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2114615" y="533400"/>
              <a:ext cx="6092305" cy="2202145"/>
              <a:chOff x="2233572" y="772391"/>
              <a:chExt cx="5462628" cy="1963154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1271"/>
              <a:stretch/>
            </p:blipFill>
            <p:spPr bwMode="auto">
              <a:xfrm>
                <a:off x="2625336" y="1229591"/>
                <a:ext cx="5070864" cy="15059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2233572" y="772391"/>
                <a:ext cx="585828" cy="381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9" name="Rectangle 8"/>
          <p:cNvSpPr/>
          <p:nvPr/>
        </p:nvSpPr>
        <p:spPr>
          <a:xfrm>
            <a:off x="5932735" y="1063425"/>
            <a:ext cx="457200" cy="387580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140061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85800" y="5791200"/>
            <a:ext cx="472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26T,48T  p.E762E( c.2286A&gt;C, GAA&gt;GAG)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1288473" y="266700"/>
            <a:ext cx="6095035" cy="5199350"/>
            <a:chOff x="1288473" y="266700"/>
            <a:chExt cx="6095035" cy="5199350"/>
          </a:xfrm>
        </p:grpSpPr>
        <p:grpSp>
          <p:nvGrpSpPr>
            <p:cNvPr id="9" name="Group 8"/>
            <p:cNvGrpSpPr/>
            <p:nvPr/>
          </p:nvGrpSpPr>
          <p:grpSpPr>
            <a:xfrm>
              <a:off x="1288473" y="1937265"/>
              <a:ext cx="6074252" cy="1845707"/>
              <a:chOff x="1295400" y="2546205"/>
              <a:chExt cx="6074252" cy="1845707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8041" r="3192"/>
              <a:stretch/>
            </p:blipFill>
            <p:spPr bwMode="auto">
              <a:xfrm>
                <a:off x="1863435" y="2915537"/>
                <a:ext cx="5506217" cy="14763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295400" y="2546205"/>
                <a:ext cx="1371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 case26T</a:t>
                </a:r>
                <a:endParaRPr lang="en-US" dirty="0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1576522" y="266700"/>
              <a:ext cx="5806985" cy="1752600"/>
              <a:chOff x="1604232" y="762000"/>
              <a:chExt cx="5806985" cy="1752600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4232" y="1007115"/>
                <a:ext cx="5806985" cy="15074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1604232" y="762000"/>
                <a:ext cx="685800" cy="381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1071" r="2507"/>
            <a:stretch/>
          </p:blipFill>
          <p:spPr bwMode="auto">
            <a:xfrm>
              <a:off x="1856508" y="4033259"/>
              <a:ext cx="5527000" cy="14327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0" name="TextBox 9"/>
          <p:cNvSpPr txBox="1"/>
          <p:nvPr/>
        </p:nvSpPr>
        <p:spPr>
          <a:xfrm>
            <a:off x="1288473" y="3886200"/>
            <a:ext cx="1759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T case 48T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5181600" y="647700"/>
            <a:ext cx="381000" cy="49911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029651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524001" y="381000"/>
            <a:ext cx="6096000" cy="3810000"/>
            <a:chOff x="1524001" y="381000"/>
            <a:chExt cx="6096000" cy="3810000"/>
          </a:xfrm>
        </p:grpSpPr>
        <p:grpSp>
          <p:nvGrpSpPr>
            <p:cNvPr id="3" name="Group 2"/>
            <p:cNvGrpSpPr/>
            <p:nvPr/>
          </p:nvGrpSpPr>
          <p:grpSpPr>
            <a:xfrm>
              <a:off x="1524001" y="2468820"/>
              <a:ext cx="6096000" cy="1722180"/>
              <a:chOff x="2085536" y="2590800"/>
              <a:chExt cx="5182038" cy="1476375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10909"/>
              <a:stretch/>
            </p:blipFill>
            <p:spPr bwMode="auto">
              <a:xfrm>
                <a:off x="2464550" y="2790825"/>
                <a:ext cx="4803024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2085536" y="2590800"/>
                <a:ext cx="79057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1524001" y="381000"/>
              <a:ext cx="5978238" cy="1962150"/>
              <a:chOff x="1828800" y="685800"/>
              <a:chExt cx="5444836" cy="1657350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r="2198"/>
              <a:stretch/>
            </p:blipFill>
            <p:spPr bwMode="auto">
              <a:xfrm>
                <a:off x="2033588" y="1066800"/>
                <a:ext cx="5240048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828800" y="685800"/>
                <a:ext cx="6856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6" name="Rectangle 5"/>
          <p:cNvSpPr/>
          <p:nvPr/>
        </p:nvSpPr>
        <p:spPr>
          <a:xfrm>
            <a:off x="4953000" y="870466"/>
            <a:ext cx="457200" cy="354913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952500" y="5105399"/>
            <a:ext cx="800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 32T p.R841R (c.2523G&gt;A, AGG&gt;AGA)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773827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143000" y="4724400"/>
            <a:ext cx="563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8T  p.P848P (c.2544G&gt;A ,CCG&gt;CCA)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1655345" y="838200"/>
            <a:ext cx="5784113" cy="3138920"/>
            <a:chOff x="1655345" y="838200"/>
            <a:chExt cx="5784113" cy="3138920"/>
          </a:xfrm>
        </p:grpSpPr>
        <p:grpSp>
          <p:nvGrpSpPr>
            <p:cNvPr id="9" name="Group 8"/>
            <p:cNvGrpSpPr/>
            <p:nvPr/>
          </p:nvGrpSpPr>
          <p:grpSpPr>
            <a:xfrm>
              <a:off x="1707846" y="2292106"/>
              <a:ext cx="5731612" cy="1685014"/>
              <a:chOff x="1707846" y="2292106"/>
              <a:chExt cx="5731612" cy="1685014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10337" y="2700770"/>
                <a:ext cx="5729121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707846" y="2292106"/>
                <a:ext cx="57815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1655345" y="838200"/>
              <a:ext cx="5741843" cy="1508413"/>
              <a:chOff x="1655345" y="838200"/>
              <a:chExt cx="5741843" cy="1508413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6607"/>
              <a:stretch/>
            </p:blipFill>
            <p:spPr bwMode="auto">
              <a:xfrm>
                <a:off x="2015290" y="1070263"/>
                <a:ext cx="5381898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1655345" y="838200"/>
                <a:ext cx="63065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10" name="Rectangle 9"/>
          <p:cNvSpPr/>
          <p:nvPr/>
        </p:nvSpPr>
        <p:spPr>
          <a:xfrm>
            <a:off x="4953000" y="1070263"/>
            <a:ext cx="381000" cy="290685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654113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53836" y="1063085"/>
            <a:ext cx="6670964" cy="3613690"/>
            <a:chOff x="1253836" y="1063085"/>
            <a:chExt cx="6670964" cy="3613690"/>
          </a:xfrm>
        </p:grpSpPr>
        <p:grpSp>
          <p:nvGrpSpPr>
            <p:cNvPr id="5" name="Group 4"/>
            <p:cNvGrpSpPr/>
            <p:nvPr/>
          </p:nvGrpSpPr>
          <p:grpSpPr>
            <a:xfrm>
              <a:off x="1295400" y="2843874"/>
              <a:ext cx="6629400" cy="1832901"/>
              <a:chOff x="1524000" y="2514600"/>
              <a:chExt cx="5662313" cy="1552575"/>
            </a:xfrm>
          </p:grpSpPr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r="2266"/>
              <a:stretch/>
            </p:blipFill>
            <p:spPr bwMode="auto">
              <a:xfrm>
                <a:off x="1572906" y="2790825"/>
                <a:ext cx="5613407" cy="12763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524000" y="2514600"/>
                <a:ext cx="685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T</a:t>
                </a:r>
                <a:endParaRPr lang="en-US" dirty="0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1253836" y="1063085"/>
              <a:ext cx="6670964" cy="1802112"/>
              <a:chOff x="1253836" y="1063085"/>
              <a:chExt cx="6670964" cy="1802112"/>
            </a:xfrm>
          </p:grpSpPr>
          <p:pic>
            <p:nvPicPr>
              <p:cNvPr id="3075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6435"/>
              <a:stretch/>
            </p:blipFill>
            <p:spPr bwMode="auto">
              <a:xfrm>
                <a:off x="1579418" y="1404167"/>
                <a:ext cx="6345382" cy="14610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1253836" y="1063085"/>
                <a:ext cx="609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WT</a:t>
                </a:r>
                <a:endParaRPr lang="en-US" dirty="0"/>
              </a:p>
            </p:txBody>
          </p:sp>
        </p:grpSp>
      </p:grpSp>
      <p:sp>
        <p:nvSpPr>
          <p:cNvPr id="9" name="TextBox 8"/>
          <p:cNvSpPr txBox="1"/>
          <p:nvPr/>
        </p:nvSpPr>
        <p:spPr>
          <a:xfrm>
            <a:off x="457200" y="5638800"/>
            <a:ext cx="502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ase </a:t>
            </a:r>
            <a:r>
              <a:rPr lang="en-US" dirty="0"/>
              <a:t>20T </a:t>
            </a:r>
            <a:r>
              <a:rPr lang="en-US" dirty="0" smtClean="0"/>
              <a:t>p.I878I ( c.2634C&gt;T, </a:t>
            </a:r>
            <a:r>
              <a:rPr lang="en-US" dirty="0"/>
              <a:t> </a:t>
            </a:r>
            <a:r>
              <a:rPr lang="en-US" dirty="0" smtClean="0"/>
              <a:t>ATC&gt;ATT)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6019800" y="1404167"/>
            <a:ext cx="457200" cy="339643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29415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0</TotalTime>
  <Words>125</Words>
  <Application>Microsoft Office PowerPoint</Application>
  <PresentationFormat>On-screen Show (4:3)</PresentationFormat>
  <Paragraphs>35</Paragraphs>
  <Slides>1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Office Theme</vt:lpstr>
      <vt:lpstr>Electropherograms of the 11 silent mutations in EGFR exons 19–23 detected in hepatocellular carcinoma tissues. (linked to Table4 in the main text)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</dc:creator>
  <cp:lastModifiedBy>002492</cp:lastModifiedBy>
  <cp:revision>73</cp:revision>
  <cp:lastPrinted>2014-12-05T05:51:40Z</cp:lastPrinted>
  <dcterms:created xsi:type="dcterms:W3CDTF">2014-12-03T14:47:29Z</dcterms:created>
  <dcterms:modified xsi:type="dcterms:W3CDTF">2015-09-15T06:13:15Z</dcterms:modified>
</cp:coreProperties>
</file>